
<file path=[Content_Types].xml><?xml version="1.0" encoding="utf-8"?>
<Types xmlns="http://schemas.openxmlformats.org/package/2006/content-types"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75" r:id="rId2"/>
  </p:sldIdLst>
  <p:sldSz cx="6400800" cy="82296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073A0DAA-6AF3-43AB-8588-CEC1D06C72B9}" styleName="Medium Style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SorterView">
  <p:normalViewPr snapVertSplitter="1" vertBarState="minimized" horzBarState="maximized">
    <p:restoredLeft sz="4650" autoAdjust="0"/>
    <p:restoredTop sz="94420" autoAdjust="0"/>
  </p:normalViewPr>
  <p:slideViewPr>
    <p:cSldViewPr>
      <p:cViewPr>
        <p:scale>
          <a:sx n="90" d="100"/>
          <a:sy n="90" d="100"/>
        </p:scale>
        <p:origin x="-3804" y="-336"/>
      </p:cViewPr>
      <p:guideLst>
        <p:guide orient="horz" pos="2592"/>
        <p:guide pos="2016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FC24FC9-0FF6-4877-8945-D5787F85793B}" type="datetimeFigureOut">
              <a:rPr lang="en-US" smtClean="0"/>
              <a:t>3/28/2017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095500" y="685800"/>
            <a:ext cx="2667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3DC12D2-479F-493B-99B2-6B964153717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8068565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480060" y="2556511"/>
            <a:ext cx="5440680" cy="1764030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60120" y="4663440"/>
            <a:ext cx="4480560" cy="210312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EB8CD5-3A83-4C99-AC1D-3342DEA67A38}" type="datetimeFigureOut">
              <a:rPr lang="en-US" smtClean="0"/>
              <a:t>3/28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75B61C-C1C8-4546-B7B3-2B280C36BB8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8250019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EB8CD5-3A83-4C99-AC1D-3342DEA67A38}" type="datetimeFigureOut">
              <a:rPr lang="en-US" smtClean="0"/>
              <a:t>3/28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75B61C-C1C8-4546-B7B3-2B280C36BB8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337712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248184" y="396240"/>
            <a:ext cx="1007903" cy="8425816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24472" y="396240"/>
            <a:ext cx="2917032" cy="8425816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EB8CD5-3A83-4C99-AC1D-3342DEA67A38}" type="datetimeFigureOut">
              <a:rPr lang="en-US" smtClean="0"/>
              <a:t>3/28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75B61C-C1C8-4546-B7B3-2B280C36BB8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4857280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EB8CD5-3A83-4C99-AC1D-3342DEA67A38}" type="datetimeFigureOut">
              <a:rPr lang="en-US" smtClean="0"/>
              <a:t>3/28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75B61C-C1C8-4546-B7B3-2B280C36BB8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2115896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05619" y="5288281"/>
            <a:ext cx="5440680" cy="163449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05619" y="3488056"/>
            <a:ext cx="5440680" cy="1800224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EB8CD5-3A83-4C99-AC1D-3342DEA67A38}" type="datetimeFigureOut">
              <a:rPr lang="en-US" smtClean="0"/>
              <a:t>3/28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75B61C-C1C8-4546-B7B3-2B280C36BB8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6977203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24473" y="2305050"/>
            <a:ext cx="1962468" cy="6517006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293620" y="2305050"/>
            <a:ext cx="1962468" cy="6517006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EB8CD5-3A83-4C99-AC1D-3342DEA67A38}" type="datetimeFigureOut">
              <a:rPr lang="en-US" smtClean="0"/>
              <a:t>3/28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75B61C-C1C8-4546-B7B3-2B280C36BB8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8709310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20040" y="329566"/>
            <a:ext cx="5760720" cy="13716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20040" y="1842136"/>
            <a:ext cx="2828132" cy="767714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20040" y="2609850"/>
            <a:ext cx="2828132" cy="474154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251518" y="1842136"/>
            <a:ext cx="2829243" cy="767714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251518" y="2609850"/>
            <a:ext cx="2829243" cy="474154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EB8CD5-3A83-4C99-AC1D-3342DEA67A38}" type="datetimeFigureOut">
              <a:rPr lang="en-US" smtClean="0"/>
              <a:t>3/28/20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75B61C-C1C8-4546-B7B3-2B280C36BB8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2667690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EB8CD5-3A83-4C99-AC1D-3342DEA67A38}" type="datetimeFigureOut">
              <a:rPr lang="en-US" smtClean="0"/>
              <a:t>3/28/20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75B61C-C1C8-4546-B7B3-2B280C36BB8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1670019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EB8CD5-3A83-4C99-AC1D-3342DEA67A38}" type="datetimeFigureOut">
              <a:rPr lang="en-US" smtClean="0"/>
              <a:t>3/28/20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75B61C-C1C8-4546-B7B3-2B280C36BB8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2087538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20040" y="327660"/>
            <a:ext cx="2105819" cy="139446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502535" y="327660"/>
            <a:ext cx="3578225" cy="7023736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20040" y="1722120"/>
            <a:ext cx="2105819" cy="5629276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EB8CD5-3A83-4C99-AC1D-3342DEA67A38}" type="datetimeFigureOut">
              <a:rPr lang="en-US" smtClean="0"/>
              <a:t>3/28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75B61C-C1C8-4546-B7B3-2B280C36BB8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8373349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254602" y="5760720"/>
            <a:ext cx="3840480" cy="680086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254602" y="735330"/>
            <a:ext cx="3840480" cy="493776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254602" y="6440806"/>
            <a:ext cx="3840480" cy="965834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EB8CD5-3A83-4C99-AC1D-3342DEA67A38}" type="datetimeFigureOut">
              <a:rPr lang="en-US" smtClean="0"/>
              <a:t>3/28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75B61C-C1C8-4546-B7B3-2B280C36BB8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7842531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20040" y="329566"/>
            <a:ext cx="5760720" cy="13716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20040" y="1920240"/>
            <a:ext cx="5760720" cy="543115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20040" y="7627621"/>
            <a:ext cx="1493520" cy="43815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3EB8CD5-3A83-4C99-AC1D-3342DEA67A38}" type="datetimeFigureOut">
              <a:rPr lang="en-US" smtClean="0"/>
              <a:t>3/28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186940" y="7627621"/>
            <a:ext cx="2026920" cy="43815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587240" y="7627621"/>
            <a:ext cx="1493520" cy="43815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275B61C-C1C8-4546-B7B3-2B280C36BB8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4469980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4038600" y="0"/>
            <a:ext cx="23622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upplementary Table S1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2" name="Table 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835335172"/>
              </p:ext>
            </p:extLst>
          </p:nvPr>
        </p:nvGraphicFramePr>
        <p:xfrm>
          <a:off x="990600" y="914400"/>
          <a:ext cx="3200400" cy="155448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2311400"/>
                <a:gridCol w="889000"/>
              </a:tblGrid>
              <a:tr h="218227">
                <a:tc>
                  <a:txBody>
                    <a:bodyPr/>
                    <a:lstStyle/>
                    <a:p>
                      <a:pPr algn="ctr"/>
                      <a:r>
                        <a:rPr lang="en-US" sz="1100" b="1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iameter</a:t>
                      </a:r>
                      <a:r>
                        <a:rPr lang="en-US" sz="1100" b="1" baseline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(TEM)</a:t>
                      </a:r>
                      <a:endParaRPr lang="en-US" sz="1100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3.1 nm</a:t>
                      </a:r>
                      <a:endParaRPr lang="en-US" sz="11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152536">
                <a:tc>
                  <a:txBody>
                    <a:bodyPr/>
                    <a:lstStyle/>
                    <a:p>
                      <a:pPr algn="ctr"/>
                      <a:r>
                        <a:rPr lang="en-US" sz="1100" b="1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irst Standard Deviation</a:t>
                      </a:r>
                      <a:endParaRPr lang="en-US" sz="1100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.9 nm</a:t>
                      </a:r>
                      <a:endParaRPr lang="en-US" sz="11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152536">
                <a:tc>
                  <a:txBody>
                    <a:bodyPr/>
                    <a:lstStyle/>
                    <a:p>
                      <a:pPr algn="ctr"/>
                      <a:r>
                        <a:rPr lang="en-US" sz="1100" b="1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oefficient of Variation</a:t>
                      </a:r>
                      <a:endParaRPr lang="en-US" sz="1100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9.8%</a:t>
                      </a:r>
                      <a:endParaRPr lang="en-US" sz="11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232101">
                <a:tc>
                  <a:txBody>
                    <a:bodyPr/>
                    <a:lstStyle/>
                    <a:p>
                      <a:pPr algn="ctr"/>
                      <a:r>
                        <a:rPr lang="en-US" sz="1100" b="1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urface</a:t>
                      </a:r>
                      <a:r>
                        <a:rPr lang="en-US" sz="1100" b="1" baseline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Area (TEM)</a:t>
                      </a:r>
                      <a:endParaRPr lang="en-US" sz="1100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1.46 m</a:t>
                      </a:r>
                      <a:r>
                        <a:rPr lang="en-US" sz="1100" baseline="3000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  <a:r>
                        <a:rPr lang="en-US" sz="110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/g</a:t>
                      </a:r>
                      <a:endParaRPr lang="en-US" sz="11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152536">
                <a:tc>
                  <a:txBody>
                    <a:bodyPr/>
                    <a:lstStyle/>
                    <a:p>
                      <a:pPr algn="ctr"/>
                      <a:r>
                        <a:rPr lang="en-US" sz="1100" b="1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ass Concentration</a:t>
                      </a:r>
                      <a:r>
                        <a:rPr lang="en-US" sz="1100" b="1" baseline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Ag</a:t>
                      </a:r>
                      <a:endParaRPr lang="en-US" sz="1100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5%</a:t>
                      </a:r>
                      <a:endParaRPr lang="en-US" sz="11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152536">
                <a:tc>
                  <a:txBody>
                    <a:bodyPr/>
                    <a:lstStyle/>
                    <a:p>
                      <a:pPr algn="ctr"/>
                      <a:r>
                        <a:rPr lang="en-US" sz="1100" b="1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ass Concentration PVP</a:t>
                      </a:r>
                      <a:endParaRPr lang="en-US" sz="1100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5%</a:t>
                      </a:r>
                      <a:endParaRPr lang="en-US" sz="11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</a:tbl>
          </a:graphicData>
        </a:graphic>
      </p:graphicFrame>
      <p:sp>
        <p:nvSpPr>
          <p:cNvPr id="3" name="TextBox 2"/>
          <p:cNvSpPr txBox="1"/>
          <p:nvPr/>
        </p:nvSpPr>
        <p:spPr>
          <a:xfrm>
            <a:off x="1009650" y="2514600"/>
            <a:ext cx="458987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Nanocomposix</a:t>
            </a:r>
            <a:r>
              <a:rPr lang="en-US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, Lot #DAC1610</a:t>
            </a:r>
            <a:endParaRPr 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89084301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7117</TotalTime>
  <Words>41</Words>
  <Application>Microsoft Office PowerPoint</Application>
  <PresentationFormat>Custom</PresentationFormat>
  <Paragraphs>14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WFUHS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ale D. Fahrenholtz</dc:creator>
  <cp:lastModifiedBy>Ravi Singh</cp:lastModifiedBy>
  <cp:revision>224</cp:revision>
  <dcterms:created xsi:type="dcterms:W3CDTF">2016-02-18T16:20:22Z</dcterms:created>
  <dcterms:modified xsi:type="dcterms:W3CDTF">2017-03-28T17:54:47Z</dcterms:modified>
</cp:coreProperties>
</file>